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ll" initials="D" lastIdx="1" clrIdx="0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5" d="100"/>
          <a:sy n="75" d="100"/>
        </p:scale>
        <p:origin x="180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357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0424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14713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5333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6272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6771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0702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398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653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30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9031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F3D77-2394-4305-BBE0-3E290C37756F}" type="datetimeFigureOut">
              <a:rPr lang="en-IN" smtClean="0"/>
              <a:t>25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16836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jp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FF93C8A-6721-4E4D-BACD-0AFA1F6857B3}"/>
              </a:ext>
            </a:extLst>
          </p:cNvPr>
          <p:cNvSpPr txBox="1"/>
          <p:nvPr/>
        </p:nvSpPr>
        <p:spPr>
          <a:xfrm>
            <a:off x="0" y="8367751"/>
            <a:ext cx="6756400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I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. 1</a:t>
            </a:r>
            <a:r>
              <a:rPr lang="en-I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PCOS phenotype in mice after 21 days of letrozole treatment. 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ange in body weight 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rus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cle profile 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atoxylin-Eosin stained ovarian sections. 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F: cystic follicle</a:t>
            </a:r>
            <a:r>
              <a:rPr lang="en-IN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GF- Graafian follicle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IN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gnification 4X.</a:t>
            </a:r>
            <a:r>
              <a:rPr lang="en-IN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rmone profile. All the values are </a:t>
            </a:r>
            <a:r>
              <a:rPr lang="en-US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as mean ± SEM; n = 6 per group; **P &lt; 0.01; ***P &lt; 0.001, ns not significant as compared to control group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800" b="0" i="0" u="none" strike="noStrike" baseline="0" dirty="0">
                <a:solidFill>
                  <a:srgbClr val="131413"/>
                </a:solidFill>
                <a:latin typeface="JwhhvfAdvTTb5929f4c"/>
              </a:rPr>
              <a:t> </a:t>
            </a:r>
            <a:endParaRPr lang="en-IN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5B34B22-F4DC-4F62-BB40-B213C31A32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3605196"/>
              </p:ext>
            </p:extLst>
          </p:nvPr>
        </p:nvGraphicFramePr>
        <p:xfrm>
          <a:off x="225425" y="1815016"/>
          <a:ext cx="3708400" cy="258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Project" r:id="rId3" imgW="3816000" imgH="2664000" progId="Prism5.Document">
                  <p:embed/>
                </p:oleObj>
              </mc:Choice>
              <mc:Fallback>
                <p:oleObj name="Prism Project" r:id="rId3" imgW="3816000" imgH="2664000" progId="Prism5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550C6B4-D77A-4841-BFA9-4D623D175B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5425" y="1815016"/>
                        <a:ext cx="3708400" cy="258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D61F2FE-2CB1-4E56-A5F1-AF42ED6602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2628747"/>
              </p:ext>
            </p:extLst>
          </p:nvPr>
        </p:nvGraphicFramePr>
        <p:xfrm>
          <a:off x="4071341" y="1933448"/>
          <a:ext cx="2295524" cy="2563942"/>
        </p:xfrm>
        <a:graphic>
          <a:graphicData uri="http://schemas.openxmlformats.org/drawingml/2006/table">
            <a:tbl>
              <a:tblPr firstRow="1" firstCol="1" bandRow="1"/>
              <a:tblGrid>
                <a:gridCol w="1008286">
                  <a:extLst>
                    <a:ext uri="{9D8B030D-6E8A-4147-A177-3AD203B41FA5}">
                      <a16:colId xmlns:a16="http://schemas.microsoft.com/office/drawing/2014/main" val="1884606422"/>
                    </a:ext>
                  </a:extLst>
                </a:gridCol>
                <a:gridCol w="733425">
                  <a:extLst>
                    <a:ext uri="{9D8B030D-6E8A-4147-A177-3AD203B41FA5}">
                      <a16:colId xmlns:a16="http://schemas.microsoft.com/office/drawing/2014/main" val="1961503718"/>
                    </a:ext>
                  </a:extLst>
                </a:gridCol>
                <a:gridCol w="553813">
                  <a:extLst>
                    <a:ext uri="{9D8B030D-6E8A-4147-A177-3AD203B41FA5}">
                      <a16:colId xmlns:a16="http://schemas.microsoft.com/office/drawing/2014/main" val="15250612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OS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6119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l Cycl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100%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18686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tended Proestrus</a:t>
                      </a:r>
                      <a:endParaRPr lang="en-IN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52957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tended Estrus </a:t>
                      </a:r>
                      <a:endParaRPr lang="en-IN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9529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tended Metaestrus</a:t>
                      </a:r>
                      <a:endParaRPr lang="en-IN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%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7061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tended </a:t>
                      </a:r>
                      <a:r>
                        <a:rPr lang="en-IN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estrus</a:t>
                      </a:r>
                      <a:endParaRPr lang="en-IN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%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6706949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91391C2-7D27-42F1-BCC4-28A752F495A4}"/>
              </a:ext>
            </a:extLst>
          </p:cNvPr>
          <p:cNvSpPr txBox="1"/>
          <p:nvPr/>
        </p:nvSpPr>
        <p:spPr>
          <a:xfrm>
            <a:off x="679450" y="1561710"/>
            <a:ext cx="419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A888B3B-C27E-4AD8-B674-6D28ABB54326}"/>
              </a:ext>
            </a:extLst>
          </p:cNvPr>
          <p:cNvSpPr txBox="1"/>
          <p:nvPr/>
        </p:nvSpPr>
        <p:spPr>
          <a:xfrm>
            <a:off x="3933825" y="1526516"/>
            <a:ext cx="419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C86D05B-4D84-4E87-B5A7-FF38C0B590C9}"/>
              </a:ext>
            </a:extLst>
          </p:cNvPr>
          <p:cNvSpPr txBox="1"/>
          <p:nvPr/>
        </p:nvSpPr>
        <p:spPr>
          <a:xfrm>
            <a:off x="1322829" y="4703734"/>
            <a:ext cx="419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C5C8A771-4676-442A-AE39-54D25C816349}"/>
              </a:ext>
            </a:extLst>
          </p:cNvPr>
          <p:cNvGrpSpPr/>
          <p:nvPr/>
        </p:nvGrpSpPr>
        <p:grpSpPr>
          <a:xfrm>
            <a:off x="1140971" y="4665312"/>
            <a:ext cx="4496946" cy="2224742"/>
            <a:chOff x="1123950" y="4659313"/>
            <a:chExt cx="4496946" cy="222474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596A6C2-93C4-4505-A1E9-43D66574B3F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3950" y="4659313"/>
              <a:ext cx="4496946" cy="2224742"/>
            </a:xfrm>
            <a:prstGeom prst="rect">
              <a:avLst/>
            </a:prstGeom>
          </p:spPr>
        </p:pic>
        <p:sp>
          <p:nvSpPr>
            <p:cNvPr id="11" name="TextBox 7">
              <a:extLst>
                <a:ext uri="{FF2B5EF4-FFF2-40B4-BE49-F238E27FC236}">
                  <a16:creationId xmlns:a16="http://schemas.microsoft.com/office/drawing/2014/main" id="{751448B8-F417-4C1F-9065-0F01C500DE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71925" y="5002967"/>
              <a:ext cx="419100" cy="303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7">
              <a:extLst>
                <a:ext uri="{FF2B5EF4-FFF2-40B4-BE49-F238E27FC236}">
                  <a16:creationId xmlns:a16="http://schemas.microsoft.com/office/drawing/2014/main" id="{78834AE3-F29D-4B9B-B6E1-9AD787158C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5200" y="5306559"/>
              <a:ext cx="419100" cy="303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7">
              <a:extLst>
                <a:ext uri="{FF2B5EF4-FFF2-40B4-BE49-F238E27FC236}">
                  <a16:creationId xmlns:a16="http://schemas.microsoft.com/office/drawing/2014/main" id="{9CF80C4F-F738-45FC-ABC8-ED67C0BDCA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95700" y="5064771"/>
              <a:ext cx="419100" cy="303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7">
              <a:extLst>
                <a:ext uri="{FF2B5EF4-FFF2-40B4-BE49-F238E27FC236}">
                  <a16:creationId xmlns:a16="http://schemas.microsoft.com/office/drawing/2014/main" id="{E380EE8B-33AF-48E6-8330-5AFDC975A3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52241" y="6048174"/>
              <a:ext cx="419100" cy="303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0">
              <a:extLst>
                <a:ext uri="{FF2B5EF4-FFF2-40B4-BE49-F238E27FC236}">
                  <a16:creationId xmlns:a16="http://schemas.microsoft.com/office/drawing/2014/main" id="{680BE0D1-758F-4B82-B286-8229779B43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9400" y="5944203"/>
              <a:ext cx="433286" cy="3035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G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0">
              <a:extLst>
                <a:ext uri="{FF2B5EF4-FFF2-40B4-BE49-F238E27FC236}">
                  <a16:creationId xmlns:a16="http://schemas.microsoft.com/office/drawing/2014/main" id="{B362470E-CB88-4E53-846F-3B9602E267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56941" y="5011511"/>
              <a:ext cx="433286" cy="3035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G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0">
              <a:extLst>
                <a:ext uri="{FF2B5EF4-FFF2-40B4-BE49-F238E27FC236}">
                  <a16:creationId xmlns:a16="http://schemas.microsoft.com/office/drawing/2014/main" id="{E1FD1A05-A1E6-46D5-A599-8A3E8B610F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79625" y="5976383"/>
              <a:ext cx="433286" cy="3035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G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0">
              <a:extLst>
                <a:ext uri="{FF2B5EF4-FFF2-40B4-BE49-F238E27FC236}">
                  <a16:creationId xmlns:a16="http://schemas.microsoft.com/office/drawing/2014/main" id="{04F5F056-80CB-4E7E-890D-A2A7D883F5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614" y="5808497"/>
              <a:ext cx="433286" cy="3035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GF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7D7A6BF4-C725-4096-BD6D-71249890788B}"/>
              </a:ext>
            </a:extLst>
          </p:cNvPr>
          <p:cNvSpPr txBox="1"/>
          <p:nvPr/>
        </p:nvSpPr>
        <p:spPr>
          <a:xfrm>
            <a:off x="1367279" y="4716704"/>
            <a:ext cx="419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DF72D4E-1EC7-4CAD-9B36-D1F0999DFF0A}"/>
              </a:ext>
            </a:extLst>
          </p:cNvPr>
          <p:cNvSpPr txBox="1"/>
          <p:nvPr/>
        </p:nvSpPr>
        <p:spPr>
          <a:xfrm>
            <a:off x="1886043" y="4734512"/>
            <a:ext cx="1065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54E4FEA-EF66-46D9-98AF-BD26EAAA688A}"/>
              </a:ext>
            </a:extLst>
          </p:cNvPr>
          <p:cNvSpPr txBox="1"/>
          <p:nvPr/>
        </p:nvSpPr>
        <p:spPr>
          <a:xfrm>
            <a:off x="3761980" y="4673358"/>
            <a:ext cx="1065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OS</a:t>
            </a:r>
          </a:p>
        </p:txBody>
      </p:sp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5493C2AE-AD1A-421B-8502-822DD58979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7248944"/>
              </p:ext>
            </p:extLst>
          </p:nvPr>
        </p:nvGraphicFramePr>
        <p:xfrm>
          <a:off x="1220083" y="6852059"/>
          <a:ext cx="4585970" cy="1303021"/>
        </p:xfrm>
        <a:graphic>
          <a:graphicData uri="http://schemas.openxmlformats.org/drawingml/2006/table">
            <a:tbl>
              <a:tblPr firstRow="1" firstCol="1" bandRow="1"/>
              <a:tblGrid>
                <a:gridCol w="627380">
                  <a:extLst>
                    <a:ext uri="{9D8B030D-6E8A-4147-A177-3AD203B41FA5}">
                      <a16:colId xmlns:a16="http://schemas.microsoft.com/office/drawing/2014/main" val="1808302279"/>
                    </a:ext>
                  </a:extLst>
                </a:gridCol>
                <a:gridCol w="1438275">
                  <a:extLst>
                    <a:ext uri="{9D8B030D-6E8A-4147-A177-3AD203B41FA5}">
                      <a16:colId xmlns:a16="http://schemas.microsoft.com/office/drawing/2014/main" val="2871488374"/>
                    </a:ext>
                  </a:extLst>
                </a:gridCol>
                <a:gridCol w="1350010">
                  <a:extLst>
                    <a:ext uri="{9D8B030D-6E8A-4147-A177-3AD203B41FA5}">
                      <a16:colId xmlns:a16="http://schemas.microsoft.com/office/drawing/2014/main" val="728173830"/>
                    </a:ext>
                  </a:extLst>
                </a:gridCol>
                <a:gridCol w="1170305">
                  <a:extLst>
                    <a:ext uri="{9D8B030D-6E8A-4147-A177-3AD203B41FA5}">
                      <a16:colId xmlns:a16="http://schemas.microsoft.com/office/drawing/2014/main" val="311422135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stosterone</a:t>
                      </a: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ng/ml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gesterone</a:t>
                      </a: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ng/ml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stradiol</a:t>
                      </a: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IN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ml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94347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650 ± 0.0533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940 ± 0.655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.25 ± 1.30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47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OS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763 ± 0.06027**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203 ± 0.2583***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.00 ± 3.433 ns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5744691"/>
                  </a:ext>
                </a:extLst>
              </a:tr>
            </a:tbl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179695EF-DF2E-49EF-B586-48E3B0157ABB}"/>
              </a:ext>
            </a:extLst>
          </p:cNvPr>
          <p:cNvSpPr txBox="1"/>
          <p:nvPr/>
        </p:nvSpPr>
        <p:spPr>
          <a:xfrm>
            <a:off x="1158705" y="6479923"/>
            <a:ext cx="419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000303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5</TotalTime>
  <Words>178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JwhhvfAdvTTb5929f4c</vt:lpstr>
      <vt:lpstr>Times New Roman</vt:lpstr>
      <vt:lpstr>Office Theme</vt:lpstr>
      <vt:lpstr>Prism Project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17</cp:revision>
  <dcterms:created xsi:type="dcterms:W3CDTF">2022-04-15T09:53:27Z</dcterms:created>
  <dcterms:modified xsi:type="dcterms:W3CDTF">2022-04-24T19:20:16Z</dcterms:modified>
</cp:coreProperties>
</file>